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7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CED67AA9-E21D-4D04-8E23-3D53009598CB}" v="1" dt="2024-10-10T06:50:17.402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2934" autoAdjust="0"/>
    <p:restoredTop sz="94660"/>
  </p:normalViewPr>
  <p:slideViewPr>
    <p:cSldViewPr snapToGrid="0">
      <p:cViewPr varScale="1">
        <p:scale>
          <a:sx n="48" d="100"/>
          <a:sy n="48" d="100"/>
        </p:scale>
        <p:origin x="2244" y="5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microsoft.com/office/2015/10/relationships/revisionInfo" Target="revisionInfo.xml"/><Relationship Id="rId3" Type="http://schemas.openxmlformats.org/officeDocument/2006/relationships/presProps" Target="presProps.xml"/><Relationship Id="rId7" Type="http://schemas.microsoft.com/office/2016/11/relationships/changesInfo" Target="changesInfos/changesInfo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赤堀　ゆきこ" userId="bbfeda90-9ade-440e-995a-5a1e8cff3baf" providerId="ADAL" clId="{CED67AA9-E21D-4D04-8E23-3D53009598CB}"/>
    <pc:docChg chg="addSld delSld modSld">
      <pc:chgData name="赤堀　ゆきこ" userId="bbfeda90-9ade-440e-995a-5a1e8cff3baf" providerId="ADAL" clId="{CED67AA9-E21D-4D04-8E23-3D53009598CB}" dt="2024-10-10T07:16:20.582" v="6" actId="20577"/>
      <pc:docMkLst>
        <pc:docMk/>
      </pc:docMkLst>
      <pc:sldChg chg="modSp add mod">
        <pc:chgData name="赤堀　ゆきこ" userId="bbfeda90-9ade-440e-995a-5a1e8cff3baf" providerId="ADAL" clId="{CED67AA9-E21D-4D04-8E23-3D53009598CB}" dt="2024-10-10T07:16:20.582" v="6" actId="20577"/>
        <pc:sldMkLst>
          <pc:docMk/>
          <pc:sldMk cId="1509033053" sldId="257"/>
        </pc:sldMkLst>
        <pc:graphicFrameChg chg="modGraphic">
          <ac:chgData name="赤堀　ゆきこ" userId="bbfeda90-9ade-440e-995a-5a1e8cff3baf" providerId="ADAL" clId="{CED67AA9-E21D-4D04-8E23-3D53009598CB}" dt="2024-10-10T07:16:20.582" v="6" actId="20577"/>
          <ac:graphicFrameMkLst>
            <pc:docMk/>
            <pc:sldMk cId="1509033053" sldId="257"/>
            <ac:graphicFrameMk id="2" creationId="{47004424-B39C-2D32-99C0-6FE8F7D197EF}"/>
          </ac:graphicFrameMkLst>
        </pc:graphicFrameChg>
      </pc:sldChg>
      <pc:sldChg chg="del">
        <pc:chgData name="赤堀　ゆきこ" userId="bbfeda90-9ade-440e-995a-5a1e8cff3baf" providerId="ADAL" clId="{CED67AA9-E21D-4D04-8E23-3D53009598CB}" dt="2024-10-10T06:50:18.856" v="1" actId="47"/>
        <pc:sldMkLst>
          <pc:docMk/>
          <pc:sldMk cId="2888254083" sldId="258"/>
        </pc:sldMkLst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2E0BBB-3399-4401-875A-1370C28E4E37}" type="datetimeFigureOut">
              <a:rPr kumimoji="1" lang="ja-JP" altLang="en-US" smtClean="0"/>
              <a:t>2024/10/1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CA8580-E68A-4957-9555-572C0B1A605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5722787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2E0BBB-3399-4401-875A-1370C28E4E37}" type="datetimeFigureOut">
              <a:rPr kumimoji="1" lang="ja-JP" altLang="en-US" smtClean="0"/>
              <a:t>2024/10/1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CA8580-E68A-4957-9555-572C0B1A605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1894986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2E0BBB-3399-4401-875A-1370C28E4E37}" type="datetimeFigureOut">
              <a:rPr kumimoji="1" lang="ja-JP" altLang="en-US" smtClean="0"/>
              <a:t>2024/10/1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CA8580-E68A-4957-9555-572C0B1A605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2526214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2E0BBB-3399-4401-875A-1370C28E4E37}" type="datetimeFigureOut">
              <a:rPr kumimoji="1" lang="ja-JP" altLang="en-US" smtClean="0"/>
              <a:t>2024/10/1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CA8580-E68A-4957-9555-572C0B1A605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5538395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82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82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2E0BBB-3399-4401-875A-1370C28E4E37}" type="datetimeFigureOut">
              <a:rPr kumimoji="1" lang="ja-JP" altLang="en-US" smtClean="0"/>
              <a:t>2024/10/1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CA8580-E68A-4957-9555-572C0B1A605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1670646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2E0BBB-3399-4401-875A-1370C28E4E37}" type="datetimeFigureOut">
              <a:rPr kumimoji="1" lang="ja-JP" altLang="en-US" smtClean="0"/>
              <a:t>2024/10/11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CA8580-E68A-4957-9555-572C0B1A605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1263672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2E0BBB-3399-4401-875A-1370C28E4E37}" type="datetimeFigureOut">
              <a:rPr kumimoji="1" lang="ja-JP" altLang="en-US" smtClean="0"/>
              <a:t>2024/10/11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CA8580-E68A-4957-9555-572C0B1A605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763651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2E0BBB-3399-4401-875A-1370C28E4E37}" type="datetimeFigureOut">
              <a:rPr kumimoji="1" lang="ja-JP" altLang="en-US" smtClean="0"/>
              <a:t>2024/10/11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CA8580-E68A-4957-9555-572C0B1A605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0351028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2E0BBB-3399-4401-875A-1370C28E4E37}" type="datetimeFigureOut">
              <a:rPr kumimoji="1" lang="ja-JP" altLang="en-US" smtClean="0"/>
              <a:t>2024/10/11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CA8580-E68A-4957-9555-572C0B1A605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9961260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2E0BBB-3399-4401-875A-1370C28E4E37}" type="datetimeFigureOut">
              <a:rPr kumimoji="1" lang="ja-JP" altLang="en-US" smtClean="0"/>
              <a:t>2024/10/11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CA8580-E68A-4957-9555-572C0B1A605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8763989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2E0BBB-3399-4401-875A-1370C28E4E37}" type="datetimeFigureOut">
              <a:rPr kumimoji="1" lang="ja-JP" altLang="en-US" smtClean="0"/>
              <a:t>2024/10/11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CA8580-E68A-4957-9555-572C0B1A605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1061603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772E0BBB-3399-4401-875A-1370C28E4E37}" type="datetimeFigureOut">
              <a:rPr kumimoji="1" lang="ja-JP" altLang="en-US" smtClean="0"/>
              <a:t>2024/10/1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9CCA8580-E68A-4957-9555-572C0B1A605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6331476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表 1">
            <a:extLst>
              <a:ext uri="{FF2B5EF4-FFF2-40B4-BE49-F238E27FC236}">
                <a16:creationId xmlns:a16="http://schemas.microsoft.com/office/drawing/2014/main" id="{47004424-B39C-2D32-99C0-6FE8F7D197EF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698587123"/>
              </p:ext>
            </p:extLst>
          </p:nvPr>
        </p:nvGraphicFramePr>
        <p:xfrm>
          <a:off x="397822" y="3605564"/>
          <a:ext cx="6062356" cy="1328082"/>
        </p:xfrm>
        <a:graphic>
          <a:graphicData uri="http://schemas.openxmlformats.org/drawingml/2006/table">
            <a:tbl>
              <a:tblPr>
                <a:tableStyleId>{9D7B26C5-4107-4FEC-AEDC-1716B250A1EF}</a:tableStyleId>
              </a:tblPr>
              <a:tblGrid>
                <a:gridCol w="640247">
                  <a:extLst>
                    <a:ext uri="{9D8B030D-6E8A-4147-A177-3AD203B41FA5}">
                      <a16:colId xmlns:a16="http://schemas.microsoft.com/office/drawing/2014/main" val="3188891745"/>
                    </a:ext>
                  </a:extLst>
                </a:gridCol>
                <a:gridCol w="492919">
                  <a:extLst>
                    <a:ext uri="{9D8B030D-6E8A-4147-A177-3AD203B41FA5}">
                      <a16:colId xmlns:a16="http://schemas.microsoft.com/office/drawing/2014/main" val="2918274223"/>
                    </a:ext>
                  </a:extLst>
                </a:gridCol>
                <a:gridCol w="492919">
                  <a:extLst>
                    <a:ext uri="{9D8B030D-6E8A-4147-A177-3AD203B41FA5}">
                      <a16:colId xmlns:a16="http://schemas.microsoft.com/office/drawing/2014/main" val="4245610574"/>
                    </a:ext>
                  </a:extLst>
                </a:gridCol>
                <a:gridCol w="492919">
                  <a:extLst>
                    <a:ext uri="{9D8B030D-6E8A-4147-A177-3AD203B41FA5}">
                      <a16:colId xmlns:a16="http://schemas.microsoft.com/office/drawing/2014/main" val="3273876164"/>
                    </a:ext>
                  </a:extLst>
                </a:gridCol>
                <a:gridCol w="492919">
                  <a:extLst>
                    <a:ext uri="{9D8B030D-6E8A-4147-A177-3AD203B41FA5}">
                      <a16:colId xmlns:a16="http://schemas.microsoft.com/office/drawing/2014/main" val="2126039983"/>
                    </a:ext>
                  </a:extLst>
                </a:gridCol>
                <a:gridCol w="492919">
                  <a:extLst>
                    <a:ext uri="{9D8B030D-6E8A-4147-A177-3AD203B41FA5}">
                      <a16:colId xmlns:a16="http://schemas.microsoft.com/office/drawing/2014/main" val="4292125556"/>
                    </a:ext>
                  </a:extLst>
                </a:gridCol>
                <a:gridCol w="492919">
                  <a:extLst>
                    <a:ext uri="{9D8B030D-6E8A-4147-A177-3AD203B41FA5}">
                      <a16:colId xmlns:a16="http://schemas.microsoft.com/office/drawing/2014/main" val="2291722073"/>
                    </a:ext>
                  </a:extLst>
                </a:gridCol>
                <a:gridCol w="492919">
                  <a:extLst>
                    <a:ext uri="{9D8B030D-6E8A-4147-A177-3AD203B41FA5}">
                      <a16:colId xmlns:a16="http://schemas.microsoft.com/office/drawing/2014/main" val="3423609911"/>
                    </a:ext>
                  </a:extLst>
                </a:gridCol>
                <a:gridCol w="492919">
                  <a:extLst>
                    <a:ext uri="{9D8B030D-6E8A-4147-A177-3AD203B41FA5}">
                      <a16:colId xmlns:a16="http://schemas.microsoft.com/office/drawing/2014/main" val="117048285"/>
                    </a:ext>
                  </a:extLst>
                </a:gridCol>
                <a:gridCol w="492919">
                  <a:extLst>
                    <a:ext uri="{9D8B030D-6E8A-4147-A177-3AD203B41FA5}">
                      <a16:colId xmlns:a16="http://schemas.microsoft.com/office/drawing/2014/main" val="2707963441"/>
                    </a:ext>
                  </a:extLst>
                </a:gridCol>
                <a:gridCol w="492919">
                  <a:extLst>
                    <a:ext uri="{9D8B030D-6E8A-4147-A177-3AD203B41FA5}">
                      <a16:colId xmlns:a16="http://schemas.microsoft.com/office/drawing/2014/main" val="1772409738"/>
                    </a:ext>
                  </a:extLst>
                </a:gridCol>
                <a:gridCol w="492919">
                  <a:extLst>
                    <a:ext uri="{9D8B030D-6E8A-4147-A177-3AD203B41FA5}">
                      <a16:colId xmlns:a16="http://schemas.microsoft.com/office/drawing/2014/main" val="2795879534"/>
                    </a:ext>
                  </a:extLst>
                </a:gridCol>
              </a:tblGrid>
              <a:tr h="150614">
                <a:tc rowSpan="2"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erotype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46" marR="6846" marT="6846" marB="0" anchor="ctr"/>
                </a:tc>
                <a:tc gridSpan="11"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nhibitory zone (mm)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46" marR="6846" marT="6846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5886967"/>
                  </a:ext>
                </a:extLst>
              </a:tr>
              <a:tr h="130076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  <a:endParaRPr lang="en-US" altLang="ja-JP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46" marR="6846" marT="6846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</a:t>
                      </a:r>
                      <a:endParaRPr lang="en-US" altLang="ja-JP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46" marR="6846" marT="6846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</a:t>
                      </a:r>
                      <a:endParaRPr lang="en-US" altLang="ja-JP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46" marR="6846" marT="6846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</a:t>
                      </a:r>
                      <a:endParaRPr lang="en-US" altLang="ja-JP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46" marR="6846" marT="6846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6</a:t>
                      </a:r>
                      <a:endParaRPr lang="en-US" altLang="ja-JP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46" marR="6846" marT="6846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9</a:t>
                      </a:r>
                      <a:endParaRPr lang="en-US" altLang="ja-JP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46" marR="6846" marT="6846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7</a:t>
                      </a:r>
                      <a:endParaRPr lang="en-US" altLang="ja-JP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46" marR="6846" marT="6846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1</a:t>
                      </a:r>
                      <a:endParaRPr lang="en-US" altLang="ja-JP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46" marR="6846" marT="6846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1</a:t>
                      </a:r>
                      <a:endParaRPr lang="en-US" altLang="ja-JP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46" marR="6846" marT="6846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5</a:t>
                      </a:r>
                      <a:endParaRPr lang="en-US" altLang="ja-JP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46" marR="6846" marT="6846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4</a:t>
                      </a:r>
                      <a:endParaRPr lang="en-US" altLang="ja-JP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46" marR="6846" marT="6846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187688304"/>
                  </a:ext>
                </a:extLst>
              </a:tr>
              <a:tr h="138291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  <a:endParaRPr lang="en-US" altLang="ja-JP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46" marR="6846" marT="6846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</a:t>
                      </a:r>
                      <a:endParaRPr lang="en-US" altLang="ja-JP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46" marR="6846" marT="6846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</a:t>
                      </a:r>
                      <a:endParaRPr lang="en-US" altLang="ja-JP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46" marR="6846" marT="6846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</a:t>
                      </a:r>
                      <a:endParaRPr lang="en-US" altLang="ja-JP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46" marR="6846" marT="6846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</a:t>
                      </a:r>
                      <a:endParaRPr lang="en-US" altLang="ja-JP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46" marR="6846" marT="6846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</a:t>
                      </a:r>
                      <a:endParaRPr lang="en-US" altLang="ja-JP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46" marR="6846" marT="6846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</a:t>
                      </a:r>
                      <a:endParaRPr lang="en-US" altLang="ja-JP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46" marR="6846" marT="6846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</a:t>
                      </a:r>
                      <a:endParaRPr lang="en-US" altLang="ja-JP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46" marR="6846" marT="6846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</a:t>
                      </a:r>
                      <a:endParaRPr lang="en-US" altLang="ja-JP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46" marR="6846" marT="6846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1</a:t>
                      </a:r>
                      <a:endParaRPr lang="en-US" altLang="ja-JP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46" marR="6846" marT="6846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</a:t>
                      </a:r>
                      <a:endParaRPr lang="en-US" altLang="ja-JP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46" marR="6846" marT="6846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1</a:t>
                      </a:r>
                      <a:endParaRPr lang="en-US" altLang="ja-JP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46" marR="6846" marT="6846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extLst>
                  <a:ext uri="{0D108BD9-81ED-4DB2-BD59-A6C34878D82A}">
                    <a16:rowId xmlns:a16="http://schemas.microsoft.com/office/drawing/2014/main" val="3753152689"/>
                  </a:ext>
                </a:extLst>
              </a:tr>
              <a:tr h="138291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  <a:endParaRPr lang="en-US" altLang="ja-JP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46" marR="6846" marT="6846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</a:t>
                      </a:r>
                      <a:endParaRPr lang="en-US" altLang="ja-JP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46" marR="6846" marT="6846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</a:t>
                      </a:r>
                      <a:endParaRPr lang="en-US" altLang="ja-JP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46" marR="6846" marT="6846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</a:t>
                      </a:r>
                      <a:endParaRPr lang="en-US" altLang="ja-JP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46" marR="6846" marT="6846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</a:t>
                      </a:r>
                      <a:endParaRPr lang="en-US" altLang="ja-JP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46" marR="6846" marT="6846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</a:t>
                      </a:r>
                      <a:endParaRPr lang="en-US" altLang="ja-JP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46" marR="6846" marT="6846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</a:t>
                      </a:r>
                      <a:endParaRPr lang="en-US" altLang="ja-JP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46" marR="6846" marT="6846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</a:t>
                      </a:r>
                      <a:endParaRPr lang="en-US" altLang="ja-JP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46" marR="6846" marT="6846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</a:t>
                      </a:r>
                      <a:endParaRPr lang="en-US" altLang="ja-JP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46" marR="6846" marT="6846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2</a:t>
                      </a:r>
                      <a:endParaRPr lang="en-US" altLang="ja-JP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46" marR="6846" marT="6846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</a:t>
                      </a:r>
                      <a:endParaRPr lang="en-US" altLang="ja-JP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46" marR="6846" marT="6846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2</a:t>
                      </a:r>
                      <a:endParaRPr lang="en-US" altLang="ja-JP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46" marR="6846" marT="6846" marB="0" anchor="ctr"/>
                </a:tc>
                <a:extLst>
                  <a:ext uri="{0D108BD9-81ED-4DB2-BD59-A6C34878D82A}">
                    <a16:rowId xmlns:a16="http://schemas.microsoft.com/office/drawing/2014/main" val="4179558614"/>
                  </a:ext>
                </a:extLst>
              </a:tr>
              <a:tr h="138291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  <a:endParaRPr lang="en-US" altLang="ja-JP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46" marR="6846" marT="6846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</a:t>
                      </a:r>
                      <a:endParaRPr lang="en-US" altLang="ja-JP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46" marR="6846" marT="6846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</a:t>
                      </a:r>
                      <a:endParaRPr lang="en-US" altLang="ja-JP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46" marR="6846" marT="6846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3</a:t>
                      </a:r>
                      <a:endParaRPr lang="en-US" altLang="ja-JP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46" marR="6846" marT="6846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</a:t>
                      </a:r>
                      <a:endParaRPr lang="en-US" altLang="ja-JP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46" marR="6846" marT="6846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</a:t>
                      </a:r>
                      <a:endParaRPr lang="en-US" altLang="ja-JP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46" marR="6846" marT="6846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</a:t>
                      </a:r>
                      <a:endParaRPr lang="en-US" altLang="ja-JP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46" marR="6846" marT="6846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</a:t>
                      </a:r>
                      <a:endParaRPr lang="en-US" altLang="ja-JP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46" marR="6846" marT="6846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</a:t>
                      </a:r>
                      <a:endParaRPr lang="en-US" altLang="ja-JP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46" marR="6846" marT="6846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2</a:t>
                      </a:r>
                      <a:endParaRPr lang="en-US" altLang="ja-JP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46" marR="6846" marT="6846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</a:t>
                      </a:r>
                      <a:endParaRPr lang="en-US" altLang="ja-JP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46" marR="6846" marT="6846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3</a:t>
                      </a:r>
                      <a:endParaRPr lang="en-US" altLang="ja-JP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46" marR="6846" marT="6846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742759165"/>
                  </a:ext>
                </a:extLst>
              </a:tr>
              <a:tr h="130076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verage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46" marR="6846" marT="6846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.0</a:t>
                      </a:r>
                      <a:endParaRPr lang="en-US" altLang="ja-JP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46" marR="6846" marT="6846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.0</a:t>
                      </a:r>
                      <a:endParaRPr lang="en-US" altLang="ja-JP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46" marR="6846" marT="6846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.0</a:t>
                      </a:r>
                      <a:endParaRPr lang="en-US" altLang="ja-JP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46" marR="6846" marT="6846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.3</a:t>
                      </a:r>
                      <a:endParaRPr lang="en-US" altLang="ja-JP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46" marR="6846" marT="6846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.0</a:t>
                      </a:r>
                      <a:endParaRPr lang="en-US" altLang="ja-JP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46" marR="6846" marT="6846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.0</a:t>
                      </a:r>
                      <a:endParaRPr lang="en-US" altLang="ja-JP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46" marR="6846" marT="6846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.0</a:t>
                      </a:r>
                      <a:endParaRPr lang="en-US" altLang="ja-JP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46" marR="6846" marT="6846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.0</a:t>
                      </a:r>
                      <a:endParaRPr lang="en-US" altLang="ja-JP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46" marR="6846" marT="6846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1.7</a:t>
                      </a:r>
                      <a:endParaRPr lang="en-US" altLang="ja-JP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46" marR="6846" marT="6846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.0</a:t>
                      </a:r>
                      <a:endParaRPr lang="en-US" altLang="ja-JP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46" marR="6846" marT="6846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2.0</a:t>
                      </a:r>
                      <a:endParaRPr lang="en-US" altLang="ja-JP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46" marR="6846" marT="6846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extLst>
                  <a:ext uri="{0D108BD9-81ED-4DB2-BD59-A6C34878D82A}">
                    <a16:rowId xmlns:a16="http://schemas.microsoft.com/office/drawing/2014/main" val="2455358847"/>
                  </a:ext>
                </a:extLst>
              </a:tr>
              <a:tr h="130076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TDEV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46" marR="6846" marT="6846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</a:t>
                      </a:r>
                      <a:endParaRPr lang="en-US" altLang="ja-JP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46" marR="6846" marT="6846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</a:t>
                      </a:r>
                      <a:endParaRPr lang="en-US" altLang="ja-JP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46" marR="6846" marT="6846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6</a:t>
                      </a:r>
                      <a:endParaRPr lang="en-US" altLang="ja-JP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46" marR="6846" marT="6846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6</a:t>
                      </a:r>
                      <a:endParaRPr lang="en-US" altLang="ja-JP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46" marR="6846" marT="6846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</a:t>
                      </a:r>
                      <a:endParaRPr lang="en-US" altLang="ja-JP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46" marR="6846" marT="6846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0</a:t>
                      </a:r>
                      <a:endParaRPr lang="en-US" altLang="ja-JP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46" marR="6846" marT="6846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</a:t>
                      </a:r>
                      <a:endParaRPr lang="en-US" altLang="ja-JP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46" marR="6846" marT="6846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</a:t>
                      </a:r>
                      <a:endParaRPr lang="en-US" altLang="ja-JP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46" marR="6846" marT="6846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6</a:t>
                      </a:r>
                      <a:endParaRPr lang="en-US" altLang="ja-JP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46" marR="6846" marT="6846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</a:t>
                      </a:r>
                      <a:endParaRPr lang="en-US" altLang="ja-JP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46" marR="6846" marT="6846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0</a:t>
                      </a:r>
                      <a:endParaRPr lang="en-US" altLang="ja-JP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46" marR="6846" marT="6846" marB="0" anchor="ctr"/>
                </a:tc>
                <a:extLst>
                  <a:ext uri="{0D108BD9-81ED-4DB2-BD59-A6C34878D82A}">
                    <a16:rowId xmlns:a16="http://schemas.microsoft.com/office/drawing/2014/main" val="2082522686"/>
                  </a:ext>
                </a:extLst>
              </a:tr>
            </a:tbl>
          </a:graphicData>
        </a:graphic>
      </p:graphicFrame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C62E31C7-3811-23E3-3DED-264029DF3E01}"/>
              </a:ext>
            </a:extLst>
          </p:cNvPr>
          <p:cNvSpPr txBox="1"/>
          <p:nvPr/>
        </p:nvSpPr>
        <p:spPr>
          <a:xfrm>
            <a:off x="813777" y="3048586"/>
            <a:ext cx="1697901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S2 dataset</a:t>
            </a:r>
          </a:p>
          <a:p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The dataset of Fig. 2B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DB3F1674-56AF-FCAF-41FD-6EDF07897388}"/>
              </a:ext>
            </a:extLst>
          </p:cNvPr>
          <p:cNvSpPr txBox="1"/>
          <p:nvPr/>
        </p:nvSpPr>
        <p:spPr>
          <a:xfrm>
            <a:off x="813777" y="2793452"/>
            <a:ext cx="1552028" cy="25513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058" dirty="0">
                <a:latin typeface="Arial" panose="020B0604020202020204" pitchFamily="34" charset="0"/>
                <a:cs typeface="Arial" panose="020B0604020202020204" pitchFamily="34" charset="0"/>
              </a:rPr>
              <a:t>Supporting information</a:t>
            </a:r>
            <a:endParaRPr lang="ja-JP" altLang="en-US" sz="1058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50903305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 テーマ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</TotalTime>
  <Words>87</Words>
  <Application>Microsoft Office PowerPoint</Application>
  <PresentationFormat>A4 210 x 297 mm</PresentationFormat>
  <Paragraphs>76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3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5" baseType="lpstr">
      <vt:lpstr>Aptos</vt:lpstr>
      <vt:lpstr>Aptos Display</vt:lpstr>
      <vt:lpstr>Arial</vt:lpstr>
      <vt:lpstr>Office テーマ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赤堀　ゆきこ</dc:creator>
  <cp:lastModifiedBy>ゆきこ 赤堀</cp:lastModifiedBy>
  <cp:revision>2</cp:revision>
  <dcterms:created xsi:type="dcterms:W3CDTF">2024-10-10T06:46:11Z</dcterms:created>
  <dcterms:modified xsi:type="dcterms:W3CDTF">2024-10-11T11:54:32Z</dcterms:modified>
</cp:coreProperties>
</file>